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86575" cy="10018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F0BB84-4A80-4783-8E07-0B6E7D1731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9EF9A-65DE-4087-814C-943C43A495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D31409-DFEA-4BE9-80A4-BE4E081CE4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1E230-CA38-414F-8BAB-1E232F01FB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37559E-4867-4869-A230-9FFB341955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22A5B-1B60-4D8C-AF26-6B0FA3491E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13BBE-F5C8-42C6-A786-22501297E2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9372A-453B-437A-9278-82DBC86037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6BB29E-D7CE-4744-B17E-F757EDAA77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86F3E-DBD4-4C69-A0AC-2675595DBB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D9AD1-9D19-41A7-AAC2-ED05CD7756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4150E-C71E-4C05-8847-C8B0078537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A70EEA-81C0-422E-AE69-7FE0C1C96DDF}" type="slidenum"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"/>
          <p:cNvSpPr/>
          <p:nvPr/>
        </p:nvSpPr>
        <p:spPr>
          <a:xfrm>
            <a:off x="55440" y="3240"/>
            <a:ext cx="9039240" cy="629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GCGCACCTCAGCACTGCTCACCTTCGTCCTTGCGACAATTGTATCCGCCCACAGTGTAATCACCTACCCGGGCTGGCG           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Met  Arg  Thr  Ser   Ala  Leu Leu  Thr  Phe  Val  Leu  Ala   Thr    Ile  Val  Ser   Al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His  Ser   Val    Ile  Thr   Tyr  Pro   Gly  Trp   Ar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GGGAACAACCTCATCACCAATGCGACCTTTCCCTATGGCATGCAATGGATATATCCAT g t a c g t t c c t t t t c g c t c a a g              1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y   Asn  Asn  Leu  Ile  Thr   Asn  Ala  Thr  Phe  Pro  Tyr  Gly  Met  Gln  Trp   Ile Tyr  Pr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a a a c a c g g g a c a a a c a a c t a a t a a a t a a c a a g GCGGTGGTCACAATGTTACAACAAACCGTACATACTGGCCCACGACA      2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                                              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s  Gly  Gly   His Asn Val  Thr   Thr   Asn  Arg  Thr  Tyr   Trp  Pro  Thr   Th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GTGGTGCCGTCGCTTTCCAGCCTGGCTGGTTCCGCGGTCACGAGACAGCATTCGCCTACATCAACATGGGCTTCGGCGA        3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y  Gly   Ala   Val  Ala  Phe Gln   Pro  Gly   Trp  Phe  Arg  Gly   His  Glu   Thr   Ala  Phe  Ala   Tyr  Ile  Asn  Met  Gly  Phe  Gly  As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GACGGTCCTGACGGTGGTCCTGCGAACATGACTCTCCCCATGATTCCCATGTTCCAGATTCTCGGTCCCACCAACAACC          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p  Gly  Pro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p  Gly  Gly  Pro  Ala   Asn  Met  Thr  Leu  Pro  Met   Ile  Pro  Met  Phe Gln   Ile  Leu  Gly   Pro  Thr   Asn   As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TTTCCCGGAACCATCTGCCTCCCTCAGGTGCCTCTGCCAAAGAACACGACAGTAAAGGCCGGAG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ACACAGCGACAA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4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 Phe Pro  Gly   Thr  Ile   Cys  Leu  Pro  Gln   Val  Pro  Leu  Pro   Lys   Asn  Thr   Thr   Val  Lys   Ala   Gly  Asp   Thr  Ala   Thr   I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CAAGT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TTGAACTCGCCATACATGGCGCAGCTCTCTACTCT g t a c g t c a c a t g c a g t c a a t c a t t t t c t t g t c a a c a g c              5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n  Val  Val   Glu  Leu  Ala   Ile   His   Gly  Ala  Ala  Leu  Tyr  S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a g c t a a t a t a a a c g t a g TGCGTCGATATCATCTTTGCAGATCCAGGTGACAAGAGACTCAAAGAGGTCAAC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GAGACCAA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6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     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s  Val   Asp  Ile  Ile   Phe  Ala  Asp  Pro   Gly  Asp  Lys   Arg   Leu  Lys  Glu  Val   Asn  Glu   Thr   As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CTGCTTCAAC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CCGACATCGGCTTCGCAGATATATACACTATCACGACCAAGGAATCCGGGTCAGACGAATACGCGA          7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s  Phe  Asn  Ser   Thr   Asp   Ile  Gly  Phe  Ala  Asp  Ile   Tyr  Thr   Ile  Thr   Thr  Lys   Glu  Ser  Gly   Ser   Asp  Glu  Tyr  A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CGAATCCGGTGCCACCCCAGCCTTCCGTCAGCTGGGCTGGATACCCCTGGTGGCAGCCGGCTTGTGGGCTTTTCTGCTA         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r  Glu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r    Gly    Ala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hr  Pro   Ala   Phe  Arg  Gln  Leu  Gly   Trp   Ile   Pro  Leu  Val   Ala   Ala  Gly  Leu  Trp  Ala   Phe  Leu Le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CGTGA     80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a   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1"/>
          <p:cNvSpPr/>
          <p:nvPr/>
        </p:nvSpPr>
        <p:spPr>
          <a:xfrm>
            <a:off x="71280" y="5931000"/>
            <a:ext cx="9090360" cy="9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The FGSG_02810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deduced amino acid sequence is displayed in three-letter code below the nucleotide sequence. The putative signal peptide sequence is underlined in the amino acid sequence. The HS601 and HS602 primers used for RT-PCR and probe preparation for Southern blot analysis are underlined in the nucleotide sequence. The small letter in the nucleotide sequence represents the putative intron. The attachment/cleavage site in the putative glycosylphosphatidylinositol (GPI) anchor addition sequence (in the amino acid sequence) is shown in bol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31T08:36:24Z</dcterms:created>
  <dc:creator>SugaHaruhisa</dc:creator>
  <dc:description/>
  <dc:language>en-US</dc:language>
  <cp:lastModifiedBy>Suga Haruhisa</cp:lastModifiedBy>
  <cp:lastPrinted>2010-10-19T05:50:54Z</cp:lastPrinted>
  <dcterms:modified xsi:type="dcterms:W3CDTF">2016-10-12T08:56:33Z</dcterms:modified>
  <cp:revision>231</cp:revision>
  <dc:subject/>
  <dc:title>スライド 1</dc:title>
</cp:coreProperties>
</file>